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383" autoAdjust="0"/>
    <p:restoredTop sz="94660"/>
  </p:normalViewPr>
  <p:slideViewPr>
    <p:cSldViewPr snapToGrid="0">
      <p:cViewPr varScale="1">
        <p:scale>
          <a:sx n="84" d="100"/>
          <a:sy n="84" d="100"/>
        </p:scale>
        <p:origin x="160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948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097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255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40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879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859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83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438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2145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464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726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0A002-9231-4873-B80D-7DA697758235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6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00" y="3348000"/>
            <a:ext cx="4286250" cy="2857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00" y="288000"/>
            <a:ext cx="4286250" cy="2857500"/>
          </a:xfrm>
          <a:prstGeom prst="rect">
            <a:avLst/>
          </a:prstGeom>
        </p:spPr>
      </p:pic>
      <p:sp>
        <p:nvSpPr>
          <p:cNvPr id="13" name="テキスト ボックス 12"/>
          <p:cNvSpPr txBox="1"/>
          <p:nvPr/>
        </p:nvSpPr>
        <p:spPr>
          <a:xfrm>
            <a:off x="-1" y="36000"/>
            <a:ext cx="2115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S-quantified dat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-1" y="3096000"/>
            <a:ext cx="2470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MA-quantified dat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21592" y="6156000"/>
            <a:ext cx="2470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bLoxBioC-quantified dat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4680000" y="1260000"/>
            <a:ext cx="12351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2%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= 0.00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4680000" y="4320000"/>
            <a:ext cx="12351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0%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= 0.02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00" y="6444000"/>
            <a:ext cx="4286250" cy="2857500"/>
          </a:xfrm>
          <a:prstGeom prst="rect">
            <a:avLst/>
          </a:prstGeom>
        </p:spPr>
      </p:pic>
      <p:sp>
        <p:nvSpPr>
          <p:cNvPr id="174" name="テキスト ボックス 173"/>
          <p:cNvSpPr txBox="1"/>
          <p:nvPr/>
        </p:nvSpPr>
        <p:spPr>
          <a:xfrm>
            <a:off x="4680000" y="7380000"/>
            <a:ext cx="12351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0%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= 0.0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9608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21</TotalTime>
  <Words>36</Words>
  <Application>Microsoft Office PowerPoint</Application>
  <PresentationFormat>A4 210 x 297 mm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幸二</dc:creator>
  <cp:lastModifiedBy>門田幸二</cp:lastModifiedBy>
  <cp:revision>83</cp:revision>
  <dcterms:created xsi:type="dcterms:W3CDTF">2015-02-09T07:01:03Z</dcterms:created>
  <dcterms:modified xsi:type="dcterms:W3CDTF">2017-09-04T05:27:32Z</dcterms:modified>
</cp:coreProperties>
</file>